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1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orient="horz" pos="423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46F890A9-2807-4EBB-B81D-B2AA78EC7F39}" styleName="Estilo oscuro 2 - Énfasis 5/Énfasis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EBBBCC-DAD2-459C-BE2E-F6DE35CF9A28}" styleName="Estilo oscuro 2 - Énfasis 3/Énfasis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0660B408-B3CF-4A94-85FC-2B1E0A45F4A2}" styleName="Estilo oscuro 2 - Énfasis 1/Énfasis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5202B0CA-FC54-4496-8BCA-5EF66A818D29}" styleName="Estilo oscuro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AF606853-7671-496A-8E4F-DF71F8EC918B}" styleName="Estilo oscuro 1 - Énfasis 6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wholeTbl>
    <a:band1H>
      <a:tcStyle>
        <a:tcBdr/>
        <a:fill>
          <a:solidFill>
            <a:schemeClr val="accent6">
              <a:shade val="60000"/>
            </a:schemeClr>
          </a:solidFill>
        </a:fill>
      </a:tcStyle>
    </a:band1H>
    <a:band1V>
      <a:tcStyle>
        <a:tcBdr/>
        <a:fill>
          <a:solidFill>
            <a:schemeClr val="accent6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6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6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6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25E5076-3810-47DD-B79F-674D7AD40C01}" styleName="Estilo oscuro 1 - Énfasis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E8034E78-7F5D-4C2E-B375-FC64B27BC917}" styleName="Estilo oscuro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9D7B26C5-4107-4FEC-AEDC-1716B250A1EF}" styleName="Estilo cl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566"/>
    <p:restoredTop sz="93575"/>
  </p:normalViewPr>
  <p:slideViewPr>
    <p:cSldViewPr snapToGrid="0">
      <p:cViewPr varScale="1">
        <p:scale>
          <a:sx n="66" d="100"/>
          <a:sy n="66" d="100"/>
        </p:scale>
        <p:origin x="960" y="192"/>
      </p:cViewPr>
      <p:guideLst>
        <p:guide orient="horz" pos="2160"/>
        <p:guide pos="2880"/>
        <p:guide orient="horz" pos="42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D1526C-9095-C846-A70B-0FB3CA36D0E9}" type="datetimeFigureOut">
              <a:rPr lang="es-ES" smtClean="0"/>
              <a:t>3/6/19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C46150-FE0A-644F-9B06-944E72A71CE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141314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1089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22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9709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3103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820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554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33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42787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682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624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799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063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a 1">
            <a:extLst>
              <a:ext uri="{FF2B5EF4-FFF2-40B4-BE49-F238E27FC236}">
                <a16:creationId xmlns:a16="http://schemas.microsoft.com/office/drawing/2014/main" id="{49848325-22CE-3E49-806B-2F57EF18FEC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09852088"/>
              </p:ext>
            </p:extLst>
          </p:nvPr>
        </p:nvGraphicFramePr>
        <p:xfrm>
          <a:off x="616579" y="1947368"/>
          <a:ext cx="8021812" cy="2194560"/>
        </p:xfrm>
        <a:graphic>
          <a:graphicData uri="http://schemas.openxmlformats.org/drawingml/2006/table">
            <a:tbl>
              <a:tblPr/>
              <a:tblGrid>
                <a:gridCol w="2083590">
                  <a:extLst>
                    <a:ext uri="{9D8B030D-6E8A-4147-A177-3AD203B41FA5}">
                      <a16:colId xmlns:a16="http://schemas.microsoft.com/office/drawing/2014/main" val="437513962"/>
                    </a:ext>
                  </a:extLst>
                </a:gridCol>
                <a:gridCol w="4668819">
                  <a:extLst>
                    <a:ext uri="{9D8B030D-6E8A-4147-A177-3AD203B41FA5}">
                      <a16:colId xmlns:a16="http://schemas.microsoft.com/office/drawing/2014/main" val="3332291695"/>
                    </a:ext>
                  </a:extLst>
                </a:gridCol>
                <a:gridCol w="1269403">
                  <a:extLst>
                    <a:ext uri="{9D8B030D-6E8A-4147-A177-3AD203B41FA5}">
                      <a16:colId xmlns:a16="http://schemas.microsoft.com/office/drawing/2014/main" val="1554160759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sz="1800" b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ligosaccharide</a:t>
                      </a:r>
                      <a:endParaRPr lang="es-ES" sz="1800" b="1" dirty="0">
                        <a:effectLst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sz="1800" b="1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tructure</a:t>
                      </a:r>
                      <a:endParaRPr lang="es-ES" sz="1800" b="1" dirty="0">
                        <a:effectLst/>
                      </a:endParaRPr>
                    </a:p>
                  </a:txBody>
                  <a:tcPr marL="68580" marR="68580" marT="0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sz="1800" b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f.</a:t>
                      </a:r>
                      <a:endParaRPr lang="es-ES" sz="1800" b="1" dirty="0">
                        <a:effectLst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0003943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b="0" dirty="0" err="1">
                          <a:effectLst/>
                        </a:rPr>
                        <a:t>Lewis</a:t>
                      </a:r>
                      <a:r>
                        <a:rPr lang="es-ES" b="0" baseline="30000" dirty="0" err="1">
                          <a:effectLst/>
                        </a:rPr>
                        <a:t>a</a:t>
                      </a:r>
                      <a:r>
                        <a:rPr lang="es-ES" b="0" dirty="0">
                          <a:effectLst/>
                        </a:rPr>
                        <a:t>, Le</a:t>
                      </a:r>
                      <a:r>
                        <a:rPr lang="es-ES" b="0" baseline="30000" dirty="0">
                          <a:effectLst/>
                        </a:rPr>
                        <a:t>a</a:t>
                      </a:r>
                      <a:endParaRPr lang="es-ES" b="0" dirty="0">
                        <a:effectLst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b="0" dirty="0">
                          <a:effectLst/>
                        </a:rPr>
                        <a:t>Gal</a:t>
                      </a:r>
                      <a:r>
                        <a:rPr lang="el-GR" b="0" dirty="0">
                          <a:effectLst/>
                        </a:rPr>
                        <a:t>β1,3(</a:t>
                      </a:r>
                      <a:r>
                        <a:rPr lang="es-ES" b="0" dirty="0" err="1">
                          <a:effectLst/>
                        </a:rPr>
                        <a:t>Fuc</a:t>
                      </a:r>
                      <a:r>
                        <a:rPr lang="el-GR" b="0" dirty="0">
                          <a:effectLst/>
                        </a:rPr>
                        <a:t>α1,4)</a:t>
                      </a:r>
                      <a:r>
                        <a:rPr lang="es-ES" b="0" dirty="0" err="1">
                          <a:effectLst/>
                        </a:rPr>
                        <a:t>GlcNAc</a:t>
                      </a:r>
                      <a:r>
                        <a:rPr lang="el-GR" b="0" dirty="0">
                          <a:effectLst/>
                        </a:rPr>
                        <a:t>β-</a:t>
                      </a:r>
                      <a:r>
                        <a:rPr lang="es-ES" b="0" dirty="0">
                          <a:effectLst/>
                        </a:rPr>
                        <a:t>sp3-PAA-biot</a:t>
                      </a:r>
                    </a:p>
                  </a:txBody>
                  <a:tcPr marL="68580" marR="68580" marT="0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b="0">
                          <a:effectLst/>
                        </a:rPr>
                        <a:t>0040-BP</a:t>
                      </a:r>
                    </a:p>
                  </a:txBody>
                  <a:tcPr marL="68580" marR="68580" marT="0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7857206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b="0" dirty="0" err="1">
                          <a:effectLst/>
                        </a:rPr>
                        <a:t>Lewis</a:t>
                      </a:r>
                      <a:r>
                        <a:rPr lang="es-ES" b="0" baseline="30000" dirty="0" err="1">
                          <a:effectLst/>
                        </a:rPr>
                        <a:t>c</a:t>
                      </a:r>
                      <a:r>
                        <a:rPr lang="es-ES" b="0" dirty="0">
                          <a:effectLst/>
                        </a:rPr>
                        <a:t>, </a:t>
                      </a:r>
                      <a:r>
                        <a:rPr lang="es-ES" b="0" dirty="0" err="1">
                          <a:effectLst/>
                        </a:rPr>
                        <a:t>Le</a:t>
                      </a:r>
                      <a:r>
                        <a:rPr lang="es-ES" b="0" baseline="30000" dirty="0" err="1">
                          <a:effectLst/>
                        </a:rPr>
                        <a:t>c</a:t>
                      </a:r>
                      <a:r>
                        <a:rPr lang="es-ES" b="0" dirty="0">
                          <a:effectLst/>
                        </a:rPr>
                        <a:t>, LNB</a:t>
                      </a: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b="0" dirty="0">
                          <a:effectLst/>
                        </a:rPr>
                        <a:t>Gal</a:t>
                      </a:r>
                      <a:r>
                        <a:rPr lang="el-GR" b="0" dirty="0">
                          <a:effectLst/>
                        </a:rPr>
                        <a:t>β1,3</a:t>
                      </a:r>
                      <a:r>
                        <a:rPr lang="es-ES" b="0" dirty="0" err="1">
                          <a:effectLst/>
                        </a:rPr>
                        <a:t>GlcNAc</a:t>
                      </a:r>
                      <a:r>
                        <a:rPr lang="el-GR" b="0" dirty="0">
                          <a:effectLst/>
                        </a:rPr>
                        <a:t>β-</a:t>
                      </a:r>
                      <a:r>
                        <a:rPr lang="es-ES" b="0" dirty="0">
                          <a:effectLst/>
                        </a:rPr>
                        <a:t>sp3-PAA-biot</a:t>
                      </a:r>
                    </a:p>
                  </a:txBody>
                  <a:tcPr marL="68580" marR="68580" marT="0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b="0">
                          <a:effectLst/>
                        </a:rPr>
                        <a:t>0043-BP </a:t>
                      </a:r>
                    </a:p>
                  </a:txBody>
                  <a:tcPr marL="68580" marR="68580" marT="0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749282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b="0" dirty="0">
                          <a:effectLst/>
                        </a:rPr>
                        <a:t>H </a:t>
                      </a:r>
                      <a:r>
                        <a:rPr lang="es-ES" b="0" dirty="0" err="1">
                          <a:effectLst/>
                        </a:rPr>
                        <a:t>type</a:t>
                      </a:r>
                      <a:r>
                        <a:rPr lang="es-ES" b="0" dirty="0">
                          <a:effectLst/>
                        </a:rPr>
                        <a:t> 2, H2</a:t>
                      </a: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b="0" dirty="0" err="1">
                          <a:effectLst/>
                        </a:rPr>
                        <a:t>Fuc</a:t>
                      </a:r>
                      <a:r>
                        <a:rPr lang="el-GR" b="0" dirty="0">
                          <a:effectLst/>
                        </a:rPr>
                        <a:t>α1,2</a:t>
                      </a:r>
                      <a:r>
                        <a:rPr lang="es-ES" b="0" dirty="0">
                          <a:effectLst/>
                        </a:rPr>
                        <a:t>Gal</a:t>
                      </a:r>
                      <a:r>
                        <a:rPr lang="el-GR" b="0" dirty="0">
                          <a:effectLst/>
                        </a:rPr>
                        <a:t>β1,4</a:t>
                      </a:r>
                      <a:r>
                        <a:rPr lang="es-ES" b="0" dirty="0" err="1">
                          <a:effectLst/>
                        </a:rPr>
                        <a:t>GlcNAc</a:t>
                      </a:r>
                      <a:r>
                        <a:rPr lang="el-GR" b="0" dirty="0">
                          <a:effectLst/>
                        </a:rPr>
                        <a:t>β-</a:t>
                      </a:r>
                      <a:r>
                        <a:rPr lang="es-ES" b="0" dirty="0">
                          <a:effectLst/>
                        </a:rPr>
                        <a:t>sp3-PAA-biot</a:t>
                      </a:r>
                    </a:p>
                  </a:txBody>
                  <a:tcPr marL="68580" marR="68580" marT="0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b="0">
                          <a:effectLst/>
                        </a:rPr>
                        <a:t>0089-BP</a:t>
                      </a:r>
                    </a:p>
                  </a:txBody>
                  <a:tcPr marL="68580" marR="68580" marT="0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5826702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b="0">
                          <a:effectLst/>
                        </a:rPr>
                        <a:t>H type 1, H1</a:t>
                      </a: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b="0" dirty="0" err="1">
                          <a:effectLst/>
                        </a:rPr>
                        <a:t>Fuc</a:t>
                      </a:r>
                      <a:r>
                        <a:rPr lang="el-GR" b="0" dirty="0">
                          <a:effectLst/>
                        </a:rPr>
                        <a:t>α1,2</a:t>
                      </a:r>
                      <a:r>
                        <a:rPr lang="es-ES" b="0" dirty="0">
                          <a:effectLst/>
                        </a:rPr>
                        <a:t>Gal</a:t>
                      </a:r>
                      <a:r>
                        <a:rPr lang="el-GR" b="0" dirty="0">
                          <a:effectLst/>
                        </a:rPr>
                        <a:t>β1,3</a:t>
                      </a:r>
                      <a:r>
                        <a:rPr lang="es-ES" b="0" dirty="0" err="1">
                          <a:effectLst/>
                        </a:rPr>
                        <a:t>GlcNAc</a:t>
                      </a:r>
                      <a:r>
                        <a:rPr lang="el-GR" b="0" dirty="0">
                          <a:effectLst/>
                        </a:rPr>
                        <a:t>β-</a:t>
                      </a:r>
                      <a:r>
                        <a:rPr lang="es-ES" b="0" dirty="0">
                          <a:effectLst/>
                        </a:rPr>
                        <a:t>sp3-PAA-biot</a:t>
                      </a:r>
                    </a:p>
                  </a:txBody>
                  <a:tcPr marL="68580" marR="68580" marT="0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b="0">
                          <a:effectLst/>
                        </a:rPr>
                        <a:t>0042-BP </a:t>
                      </a:r>
                    </a:p>
                  </a:txBody>
                  <a:tcPr marL="68580" marR="68580" marT="0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5958299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b="0">
                          <a:effectLst/>
                        </a:rPr>
                        <a:t>A trisaccharide, A</a:t>
                      </a:r>
                      <a:r>
                        <a:rPr lang="es-ES" b="0" baseline="-25000">
                          <a:effectLst/>
                        </a:rPr>
                        <a:t>tri </a:t>
                      </a:r>
                      <a:endParaRPr lang="es-ES" b="0">
                        <a:effectLst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b="0" dirty="0" err="1">
                          <a:effectLst/>
                        </a:rPr>
                        <a:t>GalNAc</a:t>
                      </a:r>
                      <a:r>
                        <a:rPr lang="el-GR" b="0" dirty="0">
                          <a:effectLst/>
                        </a:rPr>
                        <a:t>α1,3(</a:t>
                      </a:r>
                      <a:r>
                        <a:rPr lang="es-ES" b="0" dirty="0" err="1">
                          <a:effectLst/>
                        </a:rPr>
                        <a:t>Fuc</a:t>
                      </a:r>
                      <a:r>
                        <a:rPr lang="el-GR" b="0" dirty="0">
                          <a:effectLst/>
                        </a:rPr>
                        <a:t>α1,2)</a:t>
                      </a:r>
                      <a:r>
                        <a:rPr lang="es-ES" b="0" dirty="0">
                          <a:effectLst/>
                        </a:rPr>
                        <a:t>Gal</a:t>
                      </a:r>
                      <a:r>
                        <a:rPr lang="el-GR" b="0" dirty="0">
                          <a:effectLst/>
                        </a:rPr>
                        <a:t>β-</a:t>
                      </a:r>
                      <a:r>
                        <a:rPr lang="es-ES" b="0" dirty="0">
                          <a:effectLst/>
                        </a:rPr>
                        <a:t>sp3-PAA-biot</a:t>
                      </a:r>
                    </a:p>
                  </a:txBody>
                  <a:tcPr marL="68580" marR="68580" marT="0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b="0">
                          <a:effectLst/>
                        </a:rPr>
                        <a:t>0085-BP </a:t>
                      </a:r>
                    </a:p>
                  </a:txBody>
                  <a:tcPr marL="68580" marR="68580" marT="0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68328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b="0">
                          <a:effectLst/>
                        </a:rPr>
                        <a:t>B trisaccharide </a:t>
                      </a: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b="0" dirty="0">
                          <a:effectLst/>
                        </a:rPr>
                        <a:t>Gal</a:t>
                      </a:r>
                      <a:r>
                        <a:rPr lang="el-GR" b="0" dirty="0">
                          <a:effectLst/>
                        </a:rPr>
                        <a:t>α1,3(</a:t>
                      </a:r>
                      <a:r>
                        <a:rPr lang="es-ES" b="0" dirty="0" err="1">
                          <a:effectLst/>
                        </a:rPr>
                        <a:t>Fuc</a:t>
                      </a:r>
                      <a:r>
                        <a:rPr lang="el-GR" b="0" dirty="0">
                          <a:effectLst/>
                        </a:rPr>
                        <a:t>α1,2)</a:t>
                      </a:r>
                      <a:r>
                        <a:rPr lang="es-ES" b="0" dirty="0">
                          <a:effectLst/>
                        </a:rPr>
                        <a:t>Gal</a:t>
                      </a:r>
                      <a:r>
                        <a:rPr lang="el-GR" b="0" dirty="0">
                          <a:effectLst/>
                        </a:rPr>
                        <a:t>β-</a:t>
                      </a:r>
                      <a:r>
                        <a:rPr lang="es-ES" b="0" dirty="0">
                          <a:effectLst/>
                        </a:rPr>
                        <a:t>sp3-PAA-biot</a:t>
                      </a:r>
                    </a:p>
                  </a:txBody>
                  <a:tcPr marL="68580" marR="68580" marT="0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b="0">
                          <a:effectLst/>
                        </a:rPr>
                        <a:t>0086-BP </a:t>
                      </a:r>
                    </a:p>
                  </a:txBody>
                  <a:tcPr marL="68580" marR="68580" marT="0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175462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b="0">
                          <a:effectLst/>
                        </a:rPr>
                        <a:t>Lewis</a:t>
                      </a:r>
                      <a:r>
                        <a:rPr lang="es-ES" b="0" baseline="30000">
                          <a:effectLst/>
                        </a:rPr>
                        <a:t>b</a:t>
                      </a:r>
                      <a:r>
                        <a:rPr lang="es-ES" b="0">
                          <a:effectLst/>
                        </a:rPr>
                        <a:t>, Le</a:t>
                      </a:r>
                      <a:r>
                        <a:rPr lang="es-ES" b="0" baseline="30000">
                          <a:effectLst/>
                        </a:rPr>
                        <a:t>b</a:t>
                      </a:r>
                      <a:endParaRPr lang="es-ES" b="0">
                        <a:effectLst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b="0" dirty="0" err="1">
                          <a:effectLst/>
                        </a:rPr>
                        <a:t>Fuc</a:t>
                      </a:r>
                      <a:r>
                        <a:rPr lang="el-GR" b="0" dirty="0">
                          <a:effectLst/>
                        </a:rPr>
                        <a:t>α1,2</a:t>
                      </a:r>
                      <a:r>
                        <a:rPr lang="es-ES" b="0" dirty="0">
                          <a:effectLst/>
                        </a:rPr>
                        <a:t>Gal</a:t>
                      </a:r>
                      <a:r>
                        <a:rPr lang="el-GR" b="0" dirty="0">
                          <a:effectLst/>
                        </a:rPr>
                        <a:t>β1,3(</a:t>
                      </a:r>
                      <a:r>
                        <a:rPr lang="es-ES" b="0" dirty="0" err="1">
                          <a:effectLst/>
                        </a:rPr>
                        <a:t>Fuc</a:t>
                      </a:r>
                      <a:r>
                        <a:rPr lang="el-GR" b="0" dirty="0">
                          <a:effectLst/>
                        </a:rPr>
                        <a:t>α1,4)</a:t>
                      </a:r>
                      <a:r>
                        <a:rPr lang="es-ES" b="0" dirty="0" err="1">
                          <a:effectLst/>
                        </a:rPr>
                        <a:t>GlcNAc</a:t>
                      </a:r>
                      <a:r>
                        <a:rPr lang="el-GR" b="0" dirty="0">
                          <a:effectLst/>
                        </a:rPr>
                        <a:t>β-</a:t>
                      </a:r>
                      <a:r>
                        <a:rPr lang="es-ES" b="0" dirty="0">
                          <a:effectLst/>
                        </a:rPr>
                        <a:t>sp3-PAA-biot</a:t>
                      </a:r>
                    </a:p>
                  </a:txBody>
                  <a:tcPr marL="68580" marR="68580" marT="0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>
                        <a:spcAft>
                          <a:spcPts val="0"/>
                        </a:spcAft>
                      </a:pPr>
                      <a:r>
                        <a:rPr lang="es-ES" b="0" dirty="0">
                          <a:effectLst/>
                        </a:rPr>
                        <a:t>0041-BP </a:t>
                      </a:r>
                    </a:p>
                  </a:txBody>
                  <a:tcPr marL="68580" marR="68580" marT="0" marB="0" anchor="b">
                    <a:lnL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1217527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8D1A371E-FC80-444F-BEC3-FB2DE784C2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6579" y="2904363"/>
            <a:ext cx="10334581" cy="64633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br>
              <a:rPr kumimoji="0" lang="es-ES" altLang="es-E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rPr>
            </a:br>
            <a:endParaRPr kumimoji="0" lang="es-ES" altLang="es-E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650781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15</TotalTime>
  <Words>95</Words>
  <Application>Microsoft Macintosh PowerPoint</Application>
  <PresentationFormat>Presentación en pantalla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esús Rodríguez Díaz</dc:creator>
  <cp:lastModifiedBy>Microsoft Office User</cp:lastModifiedBy>
  <cp:revision>54</cp:revision>
  <dcterms:created xsi:type="dcterms:W3CDTF">2018-01-15T13:22:08Z</dcterms:created>
  <dcterms:modified xsi:type="dcterms:W3CDTF">2019-06-03T11:46:52Z</dcterms:modified>
</cp:coreProperties>
</file>